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120" y="2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F5614F-CDBC-A6E4-A561-22C674BC113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B02E58C-208C-618C-667A-7705AA70166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4ED4A3-4DE5-65BC-BDB8-F3239D3AC9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1D319-BF30-44EC-B277-B544F0F57268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E51652-9E5F-EA18-130D-94D1610B90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463885-FEF4-6546-A2C6-88C8A56509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0E778-730E-4AA7-A2D0-719619F37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09688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3BD6AB-5944-E8C4-4B69-2415985145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D58EADD-985C-7145-9B87-F17575929A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E2600A-74AC-29F1-CCA4-ED47FC03E6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1D319-BF30-44EC-B277-B544F0F57268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9D8D66-7363-0B08-67D0-94599898FA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BACB0A-80A6-54E8-00C1-F2B9D2D702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0E778-730E-4AA7-A2D0-719619F37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5044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73913D0-D1A4-B3B7-9F95-7D481D4DDED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596519F-AF86-678C-2058-2E4F22DB02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DA44AA-2194-441C-7D73-EEAD06FEB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1D319-BF30-44EC-B277-B544F0F57268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8DC065-2D96-C803-11C6-5467F52CDA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D88029-F10F-DE57-1659-E946504267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0E778-730E-4AA7-A2D0-719619F37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4896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78441E-0491-1A1C-A322-35FED5B14B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1BFA1F-54D5-CC8A-CE11-43E3A40E63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E5F07F-6ABC-928D-B861-B080742C61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1D319-BF30-44EC-B277-B544F0F57268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58C68F-6CFE-F4A6-63C8-316D9304A3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29DF25-ABBC-6928-F26E-9DCEF64BFF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0E778-730E-4AA7-A2D0-719619F37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213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2C1F32-CD25-F932-56D4-F4D53B9AA6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5D3075-2E7F-DDE4-18D5-3C8A9A9B62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9BC0FF-CC81-ABD2-A0FE-BE7998B3BE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1D319-BF30-44EC-B277-B544F0F57268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5BD396-3816-B9E8-A108-05E1F3E4EC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951F52-DE18-6A02-38AE-0EF4E03000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0E778-730E-4AA7-A2D0-719619F37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9361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CE6A28-999F-2B1C-EE05-80D49574C8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D8E07A-364F-B3E0-8AC5-47DC1B6EC6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F438F3-9C06-C1E0-497E-8A5640931D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CBF7B4-6588-1BD8-58FB-47F038A6E6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1D319-BF30-44EC-B277-B544F0F57268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254EDB-95AA-2982-37D1-E7F724B96C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E14CD0-F84C-7260-5A25-9A066C8D92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0E778-730E-4AA7-A2D0-719619F37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30589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576340-7BF4-1864-6F0B-A8BDBE8174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715FC6-87DB-1212-940E-D59E9D4EFC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B8CB224-BBCF-7628-927B-20F593CE26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D6FE608-DEA1-FC04-AA39-E901B47C6BD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FDEF9C7-3AB1-FB1D-6D3D-FCB9C083E85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E01329A-9B13-7EB8-474B-6E2C5FD1DB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1D319-BF30-44EC-B277-B544F0F57268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4531186-3F8E-9E9D-3A00-B572EAC85F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0F457BD-9547-BB13-D23E-CAC388B286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0E778-730E-4AA7-A2D0-719619F37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2621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B84115-4F00-CF3F-D408-684F998985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F46F654-1939-AC26-F111-E0A36E950C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1D319-BF30-44EC-B277-B544F0F57268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3EB249C-3BE8-A59B-D01F-E40D04A10F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A9D7914-96B6-1406-6B66-732E2A91A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0E778-730E-4AA7-A2D0-719619F37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491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DF67CE9-7E4A-1537-A0C4-AFDF74FA87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1D319-BF30-44EC-B277-B544F0F57268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8670853-E2A9-FFCE-744A-02DDBECD5B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424C269-10DE-BE5E-9B46-5E8BB174BD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0E778-730E-4AA7-A2D0-719619F37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7502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4ECB62-7FB5-BE13-8FFB-9E5FDB299F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0A22EE-2FA8-C70F-994A-B558699E2B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D50B22D-93FF-9A19-0FC5-88923141FE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E22637-27C2-7651-16FB-434D9C0350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1D319-BF30-44EC-B277-B544F0F57268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F7C03A-6A66-0A02-E106-D2DCCCD197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5584FA-A2E0-1180-94EB-825C5CCB9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0E778-730E-4AA7-A2D0-719619F37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117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ED5D6C-E05A-805F-3520-69831DF58B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EB71EDF-AF5F-940B-B35F-DAB0328185C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CAAFCA5-0D1E-599F-A938-DA8C464771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58F8E70-663D-E12A-370F-9106538F2D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1D319-BF30-44EC-B277-B544F0F57268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00724A-86EA-AFAC-45B0-9118B15CC3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1CFE4E-CF11-1F71-81A8-80A7CB998B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0E778-730E-4AA7-A2D0-719619F37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2221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5E7A156-34C6-2687-6D98-4302BE4F59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21EF24-B4E8-CC03-0776-1AC03FF1DB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0A1CFD-0A58-86AD-26B8-E14B74DB73F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01D319-BF30-44EC-B277-B544F0F57268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C83A4D-085A-4953-FEAC-2428AEF7602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85F9A0-CC49-FBEC-373B-8BB9C048B78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0E778-730E-4AA7-A2D0-719619F37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0231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text, diagram, line, plot&#10;&#10;Description automatically generated">
            <a:extLst>
              <a:ext uri="{FF2B5EF4-FFF2-40B4-BE49-F238E27FC236}">
                <a16:creationId xmlns:a16="http://schemas.microsoft.com/office/drawing/2014/main" id="{EB94F946-7ED0-D863-CB9E-48D66FBA2EC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029" y="150661"/>
            <a:ext cx="9514944" cy="436568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DDB9C7D-E7A4-01D4-0676-F001E66BC691}"/>
              </a:ext>
            </a:extLst>
          </p:cNvPr>
          <p:cNvSpPr txBox="1"/>
          <p:nvPr/>
        </p:nvSpPr>
        <p:spPr>
          <a:xfrm>
            <a:off x="408029" y="4484536"/>
            <a:ext cx="10678602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ry Figure 4. ZL-2201 treatment exhibits potent antitumor efficacy in vivo. </a:t>
            </a:r>
            <a:r>
              <a:rPr lang="en-US" sz="1600" dirty="0"/>
              <a:t>(A) Individual tumor volumes of NCI-H1703 xenografts following treatment with ZL-2201 at the dosing regimens indicated</a:t>
            </a:r>
            <a:r>
              <a:rPr lang="en-US" sz="1600" b="1" dirty="0"/>
              <a:t> </a:t>
            </a:r>
            <a:r>
              <a:rPr lang="en-US" sz="1600" dirty="0"/>
              <a:t>(*p&lt;0.05 ; **p&lt;0.01  ; ***p&lt; 0.001; ****p&lt;0.0001  ). (B) Average mouse body weight changes relative to the  day ) weight for all treatments shown in (A). BID: Twice daily; QD: once daily</a:t>
            </a:r>
          </a:p>
        </p:txBody>
      </p:sp>
    </p:spTree>
    <p:extLst>
      <p:ext uri="{BB962C8B-B14F-4D97-AF65-F5344CB8AC3E}">
        <p14:creationId xmlns:p14="http://schemas.microsoft.com/office/powerpoint/2010/main" val="35368333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il Bhola</dc:creator>
  <cp:lastModifiedBy>Neil Bhola</cp:lastModifiedBy>
  <cp:revision>1</cp:revision>
  <dcterms:created xsi:type="dcterms:W3CDTF">2023-07-28T20:44:51Z</dcterms:created>
  <dcterms:modified xsi:type="dcterms:W3CDTF">2023-07-28T20:45:30Z</dcterms:modified>
</cp:coreProperties>
</file>